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73" r:id="rId3"/>
    <p:sldId id="274" r:id="rId4"/>
    <p:sldId id="275" r:id="rId5"/>
    <p:sldId id="277" r:id="rId6"/>
    <p:sldId id="278" r:id="rId7"/>
    <p:sldId id="279" r:id="rId8"/>
    <p:sldId id="276" r:id="rId9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1" autoAdjust="0"/>
    <p:restoredTop sz="94660"/>
  </p:normalViewPr>
  <p:slideViewPr>
    <p:cSldViewPr snapToGrid="0">
      <p:cViewPr varScale="1">
        <p:scale>
          <a:sx n="82" d="100"/>
          <a:sy n="82" d="100"/>
        </p:scale>
        <p:origin x="114" y="6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F97A1D-D632-1518-B7E0-D900680BDF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29C692B-4396-AC75-3936-6F2319153C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01423C-75D5-AB3D-A21E-1936E7FCE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790720-9A34-92E4-FBBE-1F5B82FD63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F0B2DB-D79D-4AD0-92AA-6224D6653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904860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CAD770-2153-20E4-589E-5113E63DB5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94A119-4A88-EEFA-7F07-F7064BCD0C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CE1409-A8B5-75DD-7290-AB14DD9B3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D6FBD2-C26E-0CC3-FC03-E6D81EF9B5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789E4C-CE91-9F87-09DF-A3A48FE3A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787502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567AD1F-DC8D-8715-E3A7-B891EBA2F3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3855DE-C387-0453-8EF0-37E955F547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D31D0-D2DC-2E39-ED6F-54A9974D9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5C46AA-0BB3-9148-21B5-C656752BB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99F6CC-B3D2-BD95-35ED-B41EA48403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433017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6FFAED-7050-74BF-F5F5-6E0BC1EE00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716F90-CD30-C2EF-6F1B-7EEF97D6689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B28E1-9D80-71B7-8543-D0AC094CE5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5A35E0-EF85-C8C9-6503-C13B9602F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119E7C-F7B0-E815-9DB9-F1D39B313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71614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9FDB73-C76F-DBC3-A790-B59D5F727F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302A0F-66C6-9430-858D-6C01FCC65F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B3576-C0A5-A9B9-2906-271873B158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D7D0AC-074B-6366-4F0D-463C297C36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660865-7DB6-7C68-E583-52653296A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27857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5C42F2-B827-9FA3-B2C2-246083B00B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9E5ABA-B68F-197B-5090-F348D8AAF7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2CCBB2-EBA1-45C3-4822-C6B02A720F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D1E5F3-3333-EFF2-41EC-1A58624530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0B8D19-52DD-D9C7-C1CD-CC987839F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670FC1-444B-B8CE-E32C-67883D04F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05045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43CDD-197B-B9F3-0838-3559FB63A4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7E4C6-832A-5DC6-F8CB-10A384E345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D97B0C-ADD8-261B-5165-23A036B5C2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E6EFDD-E7CB-A0B4-47FE-DD5232EADD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C8B2351-A01B-CBBC-7656-ED5D49AC3B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438A1E-ED4F-3E8C-C5B4-8C8B8319D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3FA1F41-6FA4-69F3-F1EA-B717C5A123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F1B51A-CC36-137A-DEB9-D42421F1E5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363057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43FB77-9003-23DC-29B6-E462016A1A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C62C9B-A409-B793-FD01-D9EF07542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5F5D32-E8CF-3C7D-C100-066B283418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DDE20CB-6EB7-8EFD-8B5C-F986276C5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671971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381157F-3362-7192-BCE0-37180A8FE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CD49C34-28AB-4822-C81A-68F3F3BE54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94902C-9F74-80D6-8F5A-AD5028F218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2207925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1B0833-2B58-0D54-BAF9-7ADC8BE3B9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3D098D8-AA15-347F-FDF3-B0F642D925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CB75FCD-F7EA-89D0-A419-A54D643D2E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61BE10-19AE-1686-3BF4-623D74BA6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42B649-BE65-C169-8CCC-EFF6E2E81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587C63-3CF9-4C6E-A58C-7D0BBDAB23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520354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6ECDCD-0341-9F69-BA26-4368D04A7F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D00CCE-5AEB-633D-BBF6-D649A05953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A33CBE-5C43-A492-BF8F-5B053090AE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65F82B3-E9EA-DEAF-3046-0A2787EE1D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4E2718-7ECA-7DA0-38E9-383C3103D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4FB144-9C69-BDAE-FA38-2D62383FD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94047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CB82CD-484C-FFCB-2CA2-C429159C3C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a-DK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159859-831B-63C9-2E7D-CC71B9ADCF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a-DK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33BEE1-4B37-DC13-A5FC-56F5795498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420CA93-DE98-48AB-84C2-2F60ED614327}" type="datetimeFigureOut">
              <a:rPr lang="da-DK" smtClean="0"/>
              <a:t>15-12-2023</a:t>
            </a:fld>
            <a:endParaRPr lang="da-DK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99083F-8CE3-3285-6BEA-3A0413F0E0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0DBDC81-7F0B-8D4D-040A-5D21861CED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A36EDB7-CDBA-48B2-AA78-C5433E73FA05}" type="slidenum">
              <a:rPr lang="da-DK" smtClean="0"/>
              <a:t>‹#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29002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2.emf"/><Relationship Id="rId5" Type="http://schemas.openxmlformats.org/officeDocument/2006/relationships/image" Target="../media/image9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emf"/><Relationship Id="rId4" Type="http://schemas.openxmlformats.org/officeDocument/2006/relationships/image" Target="../media/image19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CFB77E-74D8-5DB8-014A-D7975789A5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3309509"/>
            <a:ext cx="9144000" cy="2387600"/>
          </a:xfrm>
        </p:spPr>
        <p:txBody>
          <a:bodyPr/>
          <a:lstStyle/>
          <a:p>
            <a:r>
              <a:rPr lang="da-DK" dirty="0" err="1"/>
              <a:t>Supporting</a:t>
            </a:r>
            <a:r>
              <a:rPr lang="da-DK" dirty="0"/>
              <a:t> information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D31957-099B-A1FD-D8B5-A3F9DC3B774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721708" y="1229541"/>
            <a:ext cx="9144000" cy="1655762"/>
          </a:xfrm>
        </p:spPr>
        <p:txBody>
          <a:bodyPr>
            <a:normAutofit fontScale="25000" lnSpcReduction="20000"/>
          </a:bodyPr>
          <a:lstStyle/>
          <a:p>
            <a:r>
              <a:rPr lang="en-US" sz="12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Young rat microbiota extracts strongly inhibit fibrillation of α-synuclein and protect neuroblastoma cells and zebrafish against α-synuclein toxicity</a:t>
            </a:r>
            <a:endParaRPr lang="da-DK" sz="128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a-DK" sz="9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9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ohaddeseh Ghorbani Shiraz,</a:t>
            </a:r>
            <a:r>
              <a:rPr lang="en-US" sz="96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9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anni Nielsen, Ka Hang Karen Chung, Thomas Paul Davis, Casper Rasmussen, Jan J. Enghild, </a:t>
            </a:r>
            <a:r>
              <a:rPr lang="en-GB" sz="9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mille </a:t>
            </a:r>
            <a:r>
              <a:rPr lang="en-GB" sz="96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rtin-Gallausiaux</a:t>
            </a:r>
            <a:r>
              <a:rPr lang="en-US" sz="96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Yogesh Singh, Ibrahim Javed and Daniel E. Otzen</a:t>
            </a:r>
            <a:endParaRPr lang="da-DK" sz="96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4218357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9441F17-A67E-3782-0262-58DE2C86FA6E}"/>
              </a:ext>
            </a:extLst>
          </p:cNvPr>
          <p:cNvSpPr txBox="1"/>
          <p:nvPr/>
        </p:nvSpPr>
        <p:spPr>
          <a:xfrm>
            <a:off x="5424309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1</a:t>
            </a:r>
            <a:endParaRPr lang="da-DK" sz="2400" b="1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1FE7F8F2-2AB8-3E50-84F3-0944541DA88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9024" y="434975"/>
          <a:ext cx="4514850" cy="3406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477761" imgH="4888000" progId="Prism10.Document">
                  <p:embed/>
                </p:oleObj>
              </mc:Choice>
              <mc:Fallback>
                <p:oleObj name="Prism 10" r:id="rId2" imgW="6477761" imgH="4888000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FE7F8F2-2AB8-3E50-84F3-0944541DA88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9024" y="434975"/>
                        <a:ext cx="4514850" cy="3406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640CCA7-A61B-4C5C-27B5-0F3CD96A4DA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62036" y="434975"/>
          <a:ext cx="4506913" cy="3406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6465877" imgH="4888000" progId="Prism10.Document">
                  <p:embed/>
                </p:oleObj>
              </mc:Choice>
              <mc:Fallback>
                <p:oleObj name="Prism 10" r:id="rId4" imgW="6465877" imgH="4888000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0640CCA7-A61B-4C5C-27B5-0F3CD96A4D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62036" y="434975"/>
                        <a:ext cx="4506913" cy="3406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CCA75490-6249-93BD-5099-D489136EAB2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26499" y="3841750"/>
          <a:ext cx="3876675" cy="2933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6457954" imgH="4888000" progId="Prism10.Document">
                  <p:embed/>
                </p:oleObj>
              </mc:Choice>
              <mc:Fallback>
                <p:oleObj name="Prism 10" r:id="rId6" imgW="6457954" imgH="4888000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CA75490-6249-93BD-5099-D489136EAB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6499" y="3841750"/>
                        <a:ext cx="3876675" cy="2933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26FFAC7-78A1-A9FD-F278-319827029AF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63624" y="3741737"/>
          <a:ext cx="4117975" cy="311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6457954" imgH="4888000" progId="Prism10.Document">
                  <p:embed/>
                </p:oleObj>
              </mc:Choice>
              <mc:Fallback>
                <p:oleObj name="Prism 10" r:id="rId8" imgW="6457954" imgH="4888000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926FFAC7-78A1-A9FD-F278-319827029AF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63624" y="3741737"/>
                        <a:ext cx="4117975" cy="3116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247439B-09F9-CB95-46E1-6124F4F34EF2}"/>
              </a:ext>
            </a:extLst>
          </p:cNvPr>
          <p:cNvSpPr txBox="1"/>
          <p:nvPr/>
        </p:nvSpPr>
        <p:spPr>
          <a:xfrm>
            <a:off x="9281599" y="4170145"/>
            <a:ext cx="24787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 err="1"/>
              <a:t>Figure</a:t>
            </a:r>
            <a:r>
              <a:rPr lang="da-DK" b="1" dirty="0"/>
              <a:t> S1. </a:t>
            </a:r>
            <a:r>
              <a:rPr lang="da-DK" dirty="0"/>
              <a:t>Summary of </a:t>
            </a:r>
            <a:r>
              <a:rPr lang="da-DK" dirty="0" err="1"/>
              <a:t>inhibitory</a:t>
            </a:r>
            <a:r>
              <a:rPr lang="da-DK" dirty="0"/>
              <a:t> </a:t>
            </a:r>
            <a:r>
              <a:rPr lang="da-DK" dirty="0" err="1"/>
              <a:t>effects</a:t>
            </a:r>
            <a:r>
              <a:rPr lang="da-DK" dirty="0"/>
              <a:t> of </a:t>
            </a:r>
            <a:r>
              <a:rPr lang="da-DK" dirty="0" err="1"/>
              <a:t>microbiome</a:t>
            </a:r>
            <a:r>
              <a:rPr lang="da-DK" dirty="0"/>
              <a:t> </a:t>
            </a:r>
            <a:r>
              <a:rPr lang="da-DK" dirty="0" err="1"/>
              <a:t>extracts</a:t>
            </a:r>
            <a:r>
              <a:rPr lang="da-DK" dirty="0"/>
              <a:t> on </a:t>
            </a:r>
            <a:r>
              <a:rPr lang="el-GR" dirty="0"/>
              <a:t>α</a:t>
            </a:r>
            <a:r>
              <a:rPr lang="da-DK" dirty="0"/>
              <a:t>-Syn fibrillation from 4 </a:t>
            </a:r>
            <a:r>
              <a:rPr lang="da-DK" dirty="0" err="1"/>
              <a:t>different</a:t>
            </a:r>
            <a:r>
              <a:rPr lang="da-DK" dirty="0"/>
              <a:t> </a:t>
            </a:r>
            <a:r>
              <a:rPr lang="da-DK" dirty="0" err="1"/>
              <a:t>transgenic</a:t>
            </a:r>
            <a:r>
              <a:rPr lang="da-DK" dirty="0"/>
              <a:t> (TG) rats.</a:t>
            </a:r>
            <a:endParaRPr lang="da-DK" b="1" dirty="0"/>
          </a:p>
        </p:txBody>
      </p:sp>
    </p:spTree>
    <p:extLst>
      <p:ext uri="{BB962C8B-B14F-4D97-AF65-F5344CB8AC3E}">
        <p14:creationId xmlns:p14="http://schemas.microsoft.com/office/powerpoint/2010/main" val="24747117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75B7C2E-FBCF-852E-1211-C23AA9AD8B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20308" y="1920982"/>
          <a:ext cx="4349762" cy="3281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6488565" imgH="4894121" progId="Prism10.Document">
                  <p:embed/>
                </p:oleObj>
              </mc:Choice>
              <mc:Fallback>
                <p:oleObj name="Prism 10" r:id="rId2" imgW="6488565" imgH="4894121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75B7C2E-FBCF-852E-1211-C23AA9AD8BA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0308" y="1920982"/>
                        <a:ext cx="4349762" cy="3281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3320924-5856-7951-321D-806CB9411CD0}"/>
              </a:ext>
            </a:extLst>
          </p:cNvPr>
          <p:cNvSpPr txBox="1"/>
          <p:nvPr/>
        </p:nvSpPr>
        <p:spPr>
          <a:xfrm>
            <a:off x="5424309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2</a:t>
            </a:r>
            <a:endParaRPr lang="da-DK" sz="2400" b="1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42AB2B3-CFC9-2497-157D-62C36A4BC68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13317" y="1920981"/>
          <a:ext cx="4349762" cy="32812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6488565" imgH="4894121" progId="Prism10.Document">
                  <p:embed/>
                </p:oleObj>
              </mc:Choice>
              <mc:Fallback>
                <p:oleObj name="Prism 10" r:id="rId4" imgW="6488565" imgH="4894121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A42AB2B3-CFC9-2497-157D-62C36A4BC6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13317" y="1920981"/>
                        <a:ext cx="4349762" cy="32812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BD0ABCCC-01DA-37FC-36F2-C0A6B3DAA84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784126" y="1874890"/>
          <a:ext cx="4471962" cy="33733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6488565" imgH="4894121" progId="Prism10.Document">
                  <p:embed/>
                </p:oleObj>
              </mc:Choice>
              <mc:Fallback>
                <p:oleObj name="Prism 10" r:id="rId6" imgW="6488565" imgH="4894121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BD0ABCCC-01DA-37FC-36F2-C0A6B3DAA84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784126" y="1874890"/>
                        <a:ext cx="4471962" cy="33733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B28473A9-2A75-62F2-7486-1D50B42CFC00}"/>
              </a:ext>
            </a:extLst>
          </p:cNvPr>
          <p:cNvSpPr txBox="1"/>
          <p:nvPr/>
        </p:nvSpPr>
        <p:spPr>
          <a:xfrm>
            <a:off x="3189716" y="5702383"/>
            <a:ext cx="54970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 err="1"/>
              <a:t>Figure</a:t>
            </a:r>
            <a:r>
              <a:rPr lang="da-DK" b="1" dirty="0"/>
              <a:t> S2. </a:t>
            </a:r>
            <a:r>
              <a:rPr lang="da-DK" dirty="0"/>
              <a:t>Summary of </a:t>
            </a:r>
            <a:r>
              <a:rPr lang="da-DK" dirty="0" err="1"/>
              <a:t>inhibitory</a:t>
            </a:r>
            <a:r>
              <a:rPr lang="da-DK" dirty="0"/>
              <a:t> </a:t>
            </a:r>
            <a:r>
              <a:rPr lang="da-DK" dirty="0" err="1"/>
              <a:t>effects</a:t>
            </a:r>
            <a:r>
              <a:rPr lang="da-DK" dirty="0"/>
              <a:t> of </a:t>
            </a:r>
            <a:r>
              <a:rPr lang="da-DK" dirty="0" err="1"/>
              <a:t>microbiome</a:t>
            </a:r>
            <a:r>
              <a:rPr lang="da-DK" dirty="0"/>
              <a:t> </a:t>
            </a:r>
            <a:r>
              <a:rPr lang="da-DK" dirty="0" err="1"/>
              <a:t>extracts</a:t>
            </a:r>
            <a:r>
              <a:rPr lang="da-DK" dirty="0"/>
              <a:t> on </a:t>
            </a:r>
            <a:r>
              <a:rPr lang="el-GR" dirty="0"/>
              <a:t>α</a:t>
            </a:r>
            <a:r>
              <a:rPr lang="da-DK" dirty="0"/>
              <a:t>-Syn fibrillation from 3 </a:t>
            </a:r>
            <a:r>
              <a:rPr lang="da-DK" dirty="0" err="1"/>
              <a:t>different</a:t>
            </a:r>
            <a:r>
              <a:rPr lang="da-DK" dirty="0"/>
              <a:t> </a:t>
            </a:r>
            <a:r>
              <a:rPr lang="da-DK" dirty="0" err="1"/>
              <a:t>wildtype</a:t>
            </a:r>
            <a:r>
              <a:rPr lang="da-DK" dirty="0"/>
              <a:t> (WT) rats.</a:t>
            </a:r>
            <a:endParaRPr lang="da-DK" b="1" dirty="0"/>
          </a:p>
        </p:txBody>
      </p:sp>
    </p:spTree>
    <p:extLst>
      <p:ext uri="{BB962C8B-B14F-4D97-AF65-F5344CB8AC3E}">
        <p14:creationId xmlns:p14="http://schemas.microsoft.com/office/powerpoint/2010/main" val="33766518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6D0DC4B-5749-75B8-B28F-28F39E9C1C7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873554"/>
          <a:ext cx="4203615" cy="2670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633437" imgH="4849835" progId="Prism10.Document">
                  <p:embed/>
                </p:oleObj>
              </mc:Choice>
              <mc:Fallback>
                <p:oleObj name="Prism 10" r:id="rId2" imgW="7633437" imgH="4849835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6D0DC4B-5749-75B8-B28F-28F39E9C1C7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873554"/>
                        <a:ext cx="4203615" cy="2670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BC204AE-CDD4-DF87-3C07-AD68319090CE}"/>
              </a:ext>
            </a:extLst>
          </p:cNvPr>
          <p:cNvSpPr txBox="1"/>
          <p:nvPr/>
        </p:nvSpPr>
        <p:spPr>
          <a:xfrm>
            <a:off x="5424309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3</a:t>
            </a:r>
            <a:endParaRPr lang="da-DK" sz="2400" b="1" dirty="0"/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E5CAE132-D986-FD45-B430-BA0DD266556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80614" y="1031123"/>
          <a:ext cx="3804948" cy="23978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7633437" imgH="4810230" progId="Prism10.Document">
                  <p:embed/>
                </p:oleObj>
              </mc:Choice>
              <mc:Fallback>
                <p:oleObj name="Prism 10" r:id="rId4" imgW="7633437" imgH="4810230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E5CAE132-D986-FD45-B430-BA0DD26655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80614" y="1031123"/>
                        <a:ext cx="3804948" cy="23978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788E0F1F-2630-44DB-B59B-CD458FE767C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875496" y="940238"/>
          <a:ext cx="4093377" cy="2579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7633437" imgH="4810230" progId="Prism10.Document">
                  <p:embed/>
                </p:oleObj>
              </mc:Choice>
              <mc:Fallback>
                <p:oleObj name="Prism 10" r:id="rId6" imgW="7633437" imgH="4810230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788E0F1F-2630-44DB-B59B-CD458FE767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875496" y="940238"/>
                        <a:ext cx="4093377" cy="25796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6B14637A-A436-9B18-226C-AC53AE75CA7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38564" y="3722881"/>
          <a:ext cx="3686488" cy="2877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6392409" imgH="4988813" progId="Prism10.Document">
                  <p:embed/>
                </p:oleObj>
              </mc:Choice>
              <mc:Fallback>
                <p:oleObj name="Prism 10" r:id="rId8" imgW="6392409" imgH="498881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6B14637A-A436-9B18-226C-AC53AE75CA7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38564" y="3722881"/>
                        <a:ext cx="3686488" cy="28772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0A164CB-D892-4AFA-C63B-D9570AA27FE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377325" y="3610768"/>
          <a:ext cx="3991362" cy="3125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6372601" imgH="4988813" progId="Prism10.Document">
                  <p:embed/>
                </p:oleObj>
              </mc:Choice>
              <mc:Fallback>
                <p:oleObj name="Prism 10" r:id="rId10" imgW="6372601" imgH="4988813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40A164CB-D892-4AFA-C63B-D9570AA27FE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377325" y="3610768"/>
                        <a:ext cx="3991362" cy="3125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AAE4933-F562-9824-81D4-CF4659A43CA9}"/>
              </a:ext>
            </a:extLst>
          </p:cNvPr>
          <p:cNvSpPr txBox="1"/>
          <p:nvPr/>
        </p:nvSpPr>
        <p:spPr>
          <a:xfrm>
            <a:off x="8920960" y="4163436"/>
            <a:ext cx="286738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b="1" dirty="0" err="1"/>
              <a:t>Figure</a:t>
            </a:r>
            <a:r>
              <a:rPr lang="da-DK" b="1" dirty="0"/>
              <a:t> S4.  </a:t>
            </a:r>
            <a:r>
              <a:rPr lang="da-DK" dirty="0" err="1"/>
              <a:t>Inhibitory</a:t>
            </a:r>
            <a:r>
              <a:rPr lang="da-DK" dirty="0"/>
              <a:t> </a:t>
            </a:r>
            <a:r>
              <a:rPr lang="da-DK" dirty="0" err="1"/>
              <a:t>effects</a:t>
            </a:r>
            <a:r>
              <a:rPr lang="da-DK" dirty="0"/>
              <a:t> of (</a:t>
            </a:r>
            <a:r>
              <a:rPr lang="da-DK" dirty="0" err="1"/>
              <a:t>a-c</a:t>
            </a:r>
            <a:r>
              <a:rPr lang="da-DK" dirty="0"/>
              <a:t>) </a:t>
            </a:r>
            <a:r>
              <a:rPr lang="da-DK" dirty="0" err="1"/>
              <a:t>size</a:t>
            </a:r>
            <a:r>
              <a:rPr lang="da-DK" dirty="0"/>
              <a:t> and (</a:t>
            </a:r>
            <a:r>
              <a:rPr lang="da-DK" dirty="0" err="1"/>
              <a:t>d-e</a:t>
            </a:r>
            <a:r>
              <a:rPr lang="da-DK" dirty="0"/>
              <a:t>) SEC </a:t>
            </a:r>
            <a:r>
              <a:rPr lang="da-DK" dirty="0" err="1"/>
              <a:t>fractions</a:t>
            </a:r>
            <a:r>
              <a:rPr lang="da-DK" dirty="0"/>
              <a:t> from </a:t>
            </a:r>
            <a:r>
              <a:rPr lang="da-DK" i="1" dirty="0" err="1"/>
              <a:t>Lactobacillus</a:t>
            </a:r>
            <a:r>
              <a:rPr lang="da-DK" i="1" dirty="0"/>
              <a:t> </a:t>
            </a:r>
            <a:r>
              <a:rPr lang="da-DK" dirty="0"/>
              <a:t>and </a:t>
            </a:r>
            <a:r>
              <a:rPr lang="da-DK" i="1" dirty="0" err="1"/>
              <a:t>Alistipes</a:t>
            </a:r>
            <a:r>
              <a:rPr lang="da-DK" dirty="0"/>
              <a:t> on </a:t>
            </a:r>
            <a:r>
              <a:rPr lang="el-GR" dirty="0"/>
              <a:t>α</a:t>
            </a:r>
            <a:r>
              <a:rPr lang="da-DK" dirty="0"/>
              <a:t>-Syn fibrillation.</a:t>
            </a:r>
            <a:endParaRPr lang="da-DK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3F966AE-87DA-2A3C-65BA-A956B364C9B8}"/>
              </a:ext>
            </a:extLst>
          </p:cNvPr>
          <p:cNvSpPr txBox="1"/>
          <p:nvPr/>
        </p:nvSpPr>
        <p:spPr>
          <a:xfrm>
            <a:off x="642257" y="709405"/>
            <a:ext cx="3369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2400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2C137BB-B57E-1439-C91F-A58CFB10D2A9}"/>
              </a:ext>
            </a:extLst>
          </p:cNvPr>
          <p:cNvSpPr txBox="1"/>
          <p:nvPr/>
        </p:nvSpPr>
        <p:spPr>
          <a:xfrm>
            <a:off x="4845872" y="709405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2400" b="1" dirty="0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77218F-7363-A4C5-A607-18F18765E789}"/>
              </a:ext>
            </a:extLst>
          </p:cNvPr>
          <p:cNvSpPr txBox="1"/>
          <p:nvPr/>
        </p:nvSpPr>
        <p:spPr>
          <a:xfrm>
            <a:off x="8508552" y="691699"/>
            <a:ext cx="3129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2400" b="1" dirty="0"/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6E7F79B-494A-D1B0-C625-A656686DACAA}"/>
              </a:ext>
            </a:extLst>
          </p:cNvPr>
          <p:cNvSpPr txBox="1"/>
          <p:nvPr/>
        </p:nvSpPr>
        <p:spPr>
          <a:xfrm>
            <a:off x="699909" y="3554426"/>
            <a:ext cx="3497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2400" b="1" dirty="0"/>
              <a:t>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F415EE-577D-E883-8925-67F614799377}"/>
              </a:ext>
            </a:extLst>
          </p:cNvPr>
          <p:cNvSpPr txBox="1"/>
          <p:nvPr/>
        </p:nvSpPr>
        <p:spPr>
          <a:xfrm>
            <a:off x="5020760" y="3536793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2400" b="1" dirty="0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06824990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26DD6772-0B03-C104-42C6-C3A22A67FFF4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02717" y="533399"/>
            <a:ext cx="5993283" cy="5977456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53FE197-2DAE-B0F7-69DB-AC84EB511B1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1" y="533399"/>
            <a:ext cx="6014256" cy="5977456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8EDB01D9-B6C8-9496-722D-35EB5A38ED38}"/>
              </a:ext>
            </a:extLst>
          </p:cNvPr>
          <p:cNvSpPr txBox="1"/>
          <p:nvPr/>
        </p:nvSpPr>
        <p:spPr>
          <a:xfrm>
            <a:off x="5424309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4</a:t>
            </a:r>
            <a:endParaRPr lang="da-DK" sz="2400" b="1" dirty="0"/>
          </a:p>
        </p:txBody>
      </p:sp>
    </p:spTree>
    <p:extLst>
      <p:ext uri="{BB962C8B-B14F-4D97-AF65-F5344CB8AC3E}">
        <p14:creationId xmlns:p14="http://schemas.microsoft.com/office/powerpoint/2010/main" val="23836582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05B148-FA4C-6B9C-14CF-C23EEC0A7C77}"/>
              </a:ext>
            </a:extLst>
          </p:cNvPr>
          <p:cNvSpPr txBox="1"/>
          <p:nvPr/>
        </p:nvSpPr>
        <p:spPr>
          <a:xfrm>
            <a:off x="5424309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4</a:t>
            </a:r>
            <a:endParaRPr lang="da-DK" sz="24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6D6589E-ED1C-26D5-64B0-9E1ED5AD1A69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141513" y="576943"/>
            <a:ext cx="5954486" cy="6017386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C4351818-AC9F-6F56-D991-2AE6185460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02207" y="614927"/>
            <a:ext cx="5948280" cy="2814073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E6CE646-DB84-3379-7082-1428A7963067}"/>
              </a:ext>
            </a:extLst>
          </p:cNvPr>
          <p:cNvSpPr txBox="1"/>
          <p:nvPr/>
        </p:nvSpPr>
        <p:spPr>
          <a:xfrm>
            <a:off x="6300490" y="4364308"/>
            <a:ext cx="5551714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1600" b="1" dirty="0" err="1"/>
              <a:t>Figure</a:t>
            </a:r>
            <a:r>
              <a:rPr lang="da-DK" sz="1600" b="1" dirty="0"/>
              <a:t> S4. </a:t>
            </a:r>
            <a:r>
              <a:rPr lang="da-DK" sz="1600" dirty="0" err="1"/>
              <a:t>Identified</a:t>
            </a:r>
            <a:r>
              <a:rPr lang="da-DK" sz="1600" dirty="0"/>
              <a:t> proteins from the rat </a:t>
            </a:r>
            <a:r>
              <a:rPr lang="da-DK" sz="1600" dirty="0" err="1"/>
              <a:t>microbiome</a:t>
            </a:r>
            <a:r>
              <a:rPr lang="da-DK" sz="1600" dirty="0"/>
              <a:t>. The </a:t>
            </a:r>
            <a:r>
              <a:rPr lang="da-DK" sz="1600" dirty="0" err="1"/>
              <a:t>summed</a:t>
            </a:r>
            <a:r>
              <a:rPr lang="da-DK" sz="1600" dirty="0"/>
              <a:t> </a:t>
            </a:r>
            <a:r>
              <a:rPr lang="da-DK" sz="1600" dirty="0" err="1"/>
              <a:t>unique</a:t>
            </a:r>
            <a:r>
              <a:rPr lang="da-DK" sz="1600" dirty="0"/>
              <a:t> </a:t>
            </a:r>
            <a:r>
              <a:rPr lang="da-DK" sz="1600" dirty="0" err="1"/>
              <a:t>peptide</a:t>
            </a:r>
            <a:r>
              <a:rPr lang="da-DK" sz="1600" dirty="0"/>
              <a:t> </a:t>
            </a:r>
            <a:r>
              <a:rPr lang="da-DK" sz="1600" dirty="0" err="1"/>
              <a:t>abundances</a:t>
            </a:r>
            <a:r>
              <a:rPr lang="da-DK" sz="1600" dirty="0"/>
              <a:t> from </a:t>
            </a:r>
            <a:r>
              <a:rPr lang="da-DK" sz="1600" dirty="0" err="1"/>
              <a:t>fraction</a:t>
            </a:r>
            <a:r>
              <a:rPr lang="da-DK" sz="1600" dirty="0"/>
              <a:t> 41-43 in rats </a:t>
            </a:r>
            <a:r>
              <a:rPr lang="da-DK" sz="1600" dirty="0" err="1"/>
              <a:t>aged</a:t>
            </a:r>
            <a:r>
              <a:rPr lang="da-DK" sz="1600" dirty="0"/>
              <a:t> 2-14 </a:t>
            </a:r>
            <a:r>
              <a:rPr lang="da-DK" sz="1600" dirty="0" err="1"/>
              <a:t>months</a:t>
            </a:r>
            <a:r>
              <a:rPr lang="da-DK" sz="1600" dirty="0"/>
              <a:t> </a:t>
            </a:r>
            <a:r>
              <a:rPr lang="da-DK" sz="1600" dirty="0" err="1"/>
              <a:t>are</a:t>
            </a:r>
            <a:r>
              <a:rPr lang="da-DK" sz="1600" dirty="0"/>
              <a:t> </a:t>
            </a:r>
            <a:r>
              <a:rPr lang="da-DK" sz="1600" dirty="0" err="1"/>
              <a:t>shown</a:t>
            </a:r>
            <a:r>
              <a:rPr lang="da-DK" sz="1600" dirty="0"/>
              <a:t>. Samples </a:t>
            </a:r>
            <a:r>
              <a:rPr lang="da-DK" sz="1600" dirty="0" err="1"/>
              <a:t>are</a:t>
            </a:r>
            <a:r>
              <a:rPr lang="da-DK" sz="1600" dirty="0"/>
              <a:t> single </a:t>
            </a:r>
            <a:r>
              <a:rPr lang="da-DK" sz="1600" dirty="0" err="1"/>
              <a:t>measurements</a:t>
            </a:r>
            <a:r>
              <a:rPr lang="da-DK" sz="1600" dirty="0"/>
              <a:t>, </a:t>
            </a:r>
            <a:r>
              <a:rPr lang="da-DK" sz="1600" dirty="0" err="1"/>
              <a:t>hence</a:t>
            </a:r>
            <a:r>
              <a:rPr lang="da-DK" sz="1600" dirty="0"/>
              <a:t> no </a:t>
            </a:r>
            <a:r>
              <a:rPr lang="da-DK" sz="1600" dirty="0" err="1"/>
              <a:t>error</a:t>
            </a:r>
            <a:r>
              <a:rPr lang="da-DK" sz="1600" dirty="0"/>
              <a:t> bars </a:t>
            </a:r>
            <a:r>
              <a:rPr lang="da-DK" sz="1600" dirty="0" err="1"/>
              <a:t>are</a:t>
            </a:r>
            <a:r>
              <a:rPr lang="da-DK" sz="1600" dirty="0"/>
              <a:t> </a:t>
            </a:r>
            <a:r>
              <a:rPr lang="da-DK" sz="1600" dirty="0" err="1"/>
              <a:t>shown</a:t>
            </a:r>
            <a:r>
              <a:rPr lang="da-DK" sz="1600" dirty="0"/>
              <a:t>. The </a:t>
            </a:r>
            <a:r>
              <a:rPr lang="da-DK" sz="1600" dirty="0" err="1"/>
              <a:t>UniProtKB</a:t>
            </a:r>
            <a:r>
              <a:rPr lang="da-DK" sz="1600" dirty="0"/>
              <a:t> </a:t>
            </a:r>
            <a:r>
              <a:rPr lang="da-DK" sz="1600" dirty="0" err="1"/>
              <a:t>entry</a:t>
            </a:r>
            <a:r>
              <a:rPr lang="da-DK" sz="1600" dirty="0"/>
              <a:t> (in </a:t>
            </a:r>
            <a:r>
              <a:rPr lang="da-DK" sz="1600" dirty="0" err="1"/>
              <a:t>brackets</a:t>
            </a:r>
            <a:r>
              <a:rPr lang="da-DK" sz="1600" dirty="0"/>
              <a:t>) and the protein </a:t>
            </a:r>
            <a:r>
              <a:rPr lang="da-DK" sz="1600" dirty="0" err="1"/>
              <a:t>name</a:t>
            </a:r>
            <a:r>
              <a:rPr lang="da-DK" sz="1600" dirty="0"/>
              <a:t> </a:t>
            </a:r>
            <a:r>
              <a:rPr lang="da-DK" sz="1600" dirty="0" err="1"/>
              <a:t>are</a:t>
            </a:r>
            <a:r>
              <a:rPr lang="da-DK" sz="1600" dirty="0"/>
              <a:t> </a:t>
            </a:r>
            <a:r>
              <a:rPr lang="da-DK" sz="1600" dirty="0" err="1"/>
              <a:t>shown</a:t>
            </a:r>
            <a:r>
              <a:rPr lang="da-DK" sz="1600" dirty="0"/>
              <a:t> in the </a:t>
            </a:r>
            <a:r>
              <a:rPr lang="da-DK" sz="1600" dirty="0" err="1"/>
              <a:t>title</a:t>
            </a:r>
            <a:r>
              <a:rPr lang="da-DK" sz="1600" dirty="0"/>
              <a:t> of </a:t>
            </a:r>
            <a:r>
              <a:rPr lang="da-DK" sz="1600" dirty="0" err="1"/>
              <a:t>each</a:t>
            </a:r>
            <a:r>
              <a:rPr lang="da-DK" sz="1600" dirty="0"/>
              <a:t> plot. The 3 </a:t>
            </a:r>
            <a:r>
              <a:rPr lang="da-DK" sz="1600" dirty="0" err="1"/>
              <a:t>boxed</a:t>
            </a:r>
            <a:r>
              <a:rPr lang="da-DK" sz="1600" dirty="0"/>
              <a:t> proteins </a:t>
            </a:r>
            <a:r>
              <a:rPr lang="da-DK" sz="1600" dirty="0" err="1"/>
              <a:t>are</a:t>
            </a:r>
            <a:r>
              <a:rPr lang="da-DK" sz="1600" dirty="0"/>
              <a:t> </a:t>
            </a:r>
            <a:r>
              <a:rPr lang="da-DK" sz="1600" dirty="0" err="1"/>
              <a:t>examples</a:t>
            </a:r>
            <a:r>
              <a:rPr lang="da-DK" sz="1600" dirty="0"/>
              <a:t> of proteins with </a:t>
            </a:r>
            <a:r>
              <a:rPr lang="da-DK" sz="1600" dirty="0" err="1"/>
              <a:t>decreasing</a:t>
            </a:r>
            <a:r>
              <a:rPr lang="da-DK" sz="1600" dirty="0"/>
              <a:t> </a:t>
            </a:r>
            <a:r>
              <a:rPr lang="da-DK" sz="1600" dirty="0" err="1"/>
              <a:t>occurrence</a:t>
            </a:r>
            <a:r>
              <a:rPr lang="da-DK" sz="1600" dirty="0"/>
              <a:t> in rats &gt; 2 </a:t>
            </a:r>
            <a:r>
              <a:rPr lang="da-DK" sz="1600" dirty="0" err="1"/>
              <a:t>months</a:t>
            </a:r>
            <a:r>
              <a:rPr lang="da-DK" sz="1600" dirty="0"/>
              <a:t> old.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BE6B02C7-E095-929B-3F67-26535B0D04AE}"/>
              </a:ext>
            </a:extLst>
          </p:cNvPr>
          <p:cNvSpPr/>
          <p:nvPr/>
        </p:nvSpPr>
        <p:spPr>
          <a:xfrm>
            <a:off x="1583107" y="5540829"/>
            <a:ext cx="1323380" cy="881743"/>
          </a:xfrm>
          <a:prstGeom prst="round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2" name="Rectangle: Rounded Corners 11">
            <a:extLst>
              <a:ext uri="{FF2B5EF4-FFF2-40B4-BE49-F238E27FC236}">
                <a16:creationId xmlns:a16="http://schemas.microsoft.com/office/drawing/2014/main" id="{A79CCF1D-8C7C-7E4F-2745-2AE3298D4D81}"/>
              </a:ext>
            </a:extLst>
          </p:cNvPr>
          <p:cNvSpPr/>
          <p:nvPr/>
        </p:nvSpPr>
        <p:spPr>
          <a:xfrm>
            <a:off x="1583107" y="2590801"/>
            <a:ext cx="1323380" cy="963387"/>
          </a:xfrm>
          <a:prstGeom prst="round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  <p:sp>
        <p:nvSpPr>
          <p:cNvPr id="13" name="Rectangle: Rounded Corners 12">
            <a:extLst>
              <a:ext uri="{FF2B5EF4-FFF2-40B4-BE49-F238E27FC236}">
                <a16:creationId xmlns:a16="http://schemas.microsoft.com/office/drawing/2014/main" id="{81DED2DB-6D15-203A-E39E-1E789A877220}"/>
              </a:ext>
            </a:extLst>
          </p:cNvPr>
          <p:cNvSpPr/>
          <p:nvPr/>
        </p:nvSpPr>
        <p:spPr>
          <a:xfrm>
            <a:off x="1583107" y="4519803"/>
            <a:ext cx="1323380" cy="963387"/>
          </a:xfrm>
          <a:prstGeom prst="round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8034084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9D40AF-1073-A240-7A6A-5DCB062D49AA}"/>
              </a:ext>
            </a:extLst>
          </p:cNvPr>
          <p:cNvSpPr txBox="1"/>
          <p:nvPr/>
        </p:nvSpPr>
        <p:spPr>
          <a:xfrm>
            <a:off x="5424309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/>
              <a:t>Figure S5</a:t>
            </a:r>
            <a:endParaRPr lang="da-DK" sz="2400" b="1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A59823C3-E656-E863-22C2-1EFB3FF1A64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041" y="461665"/>
            <a:ext cx="4850768" cy="3072999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B107469-B27D-E212-E68B-6DD41B6762F5}"/>
              </a:ext>
            </a:extLst>
          </p:cNvPr>
          <p:cNvSpPr txBox="1"/>
          <p:nvPr/>
        </p:nvSpPr>
        <p:spPr>
          <a:xfrm>
            <a:off x="9606718" y="1828886"/>
            <a:ext cx="2465540" cy="33239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da-DK" sz="1400" b="1" dirty="0" err="1"/>
              <a:t>Figure</a:t>
            </a:r>
            <a:r>
              <a:rPr lang="da-DK" sz="1400" b="1" dirty="0"/>
              <a:t> S5.</a:t>
            </a:r>
            <a:r>
              <a:rPr lang="da-DK" sz="1400" dirty="0">
                <a:solidFill>
                  <a:srgbClr val="FF0000"/>
                </a:solidFill>
              </a:rPr>
              <a:t> </a:t>
            </a:r>
            <a:r>
              <a:rPr lang="en-US" sz="1400" dirty="0">
                <a:effectLst/>
                <a:ea typeface="Calibri" panose="020F0502020204030204" pitchFamily="34" charset="0"/>
              </a:rPr>
              <a:t>MS-chromatograms. Top left: A typical chromatogram (labelled ‘Chromatography’). </a:t>
            </a:r>
            <a:r>
              <a:rPr lang="en-US" sz="1400" dirty="0">
                <a:ea typeface="Calibri" panose="020F0502020204030204" pitchFamily="34" charset="0"/>
              </a:rPr>
              <a:t>Below it we show t</a:t>
            </a:r>
            <a:r>
              <a:rPr lang="en-US" sz="1400" dirty="0">
                <a:effectLst/>
                <a:ea typeface="Calibri" panose="020F0502020204030204" pitchFamily="34" charset="0"/>
              </a:rPr>
              <a:t>he peak at 30 min as an example of a typical MS1, which consists primarily of four unknown mono-charged ions between 400-500 Da. Three additional chromatograms are shown from samples F41M2, F42M9, and F43M6. All show a similar pattern regarding retention time and relative total ion count. </a:t>
            </a:r>
            <a:endParaRPr lang="da-DK" sz="1400" dirty="0">
              <a:solidFill>
                <a:srgbClr val="FF0000"/>
              </a:solidFill>
            </a:endParaRP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CAAFF92D-0942-9E94-63E3-64E9ABED4B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10312" y="746426"/>
            <a:ext cx="4268902" cy="2682574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3367E1-1B79-2E05-C200-3DBBC2D5472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882809" y="3780597"/>
            <a:ext cx="4268902" cy="267445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99D8276-7993-B088-FBA6-246DB3F669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5774" y="3848750"/>
            <a:ext cx="4039206" cy="25381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84034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C2960982-D888-69AD-ED15-F9894A62DFDF}"/>
              </a:ext>
            </a:extLst>
          </p:cNvPr>
          <p:cNvSpPr txBox="1"/>
          <p:nvPr/>
        </p:nvSpPr>
        <p:spPr>
          <a:xfrm>
            <a:off x="1930355" y="323180"/>
            <a:ext cx="6560502" cy="966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Table S1.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ist of organisms against which MS spectra based on fractions 41-43 from SEC-purified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FRaM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amples were searched. </a:t>
            </a:r>
            <a:endParaRPr lang="da-DK" sz="16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00938329-D233-8743-6857-1C1E1CCA6113}"/>
              </a:ext>
            </a:extLst>
          </p:cNvPr>
          <p:cNvGraphicFramePr>
            <a:graphicFrameLocks noGrp="1"/>
          </p:cNvGraphicFramePr>
          <p:nvPr/>
        </p:nvGraphicFramePr>
        <p:xfrm>
          <a:off x="2073403" y="1558947"/>
          <a:ext cx="5847678" cy="509181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923839">
                  <a:extLst>
                    <a:ext uri="{9D8B030D-6E8A-4147-A177-3AD203B41FA5}">
                      <a16:colId xmlns:a16="http://schemas.microsoft.com/office/drawing/2014/main" val="1682139463"/>
                    </a:ext>
                  </a:extLst>
                </a:gridCol>
                <a:gridCol w="2923839">
                  <a:extLst>
                    <a:ext uri="{9D8B030D-6E8A-4147-A177-3AD203B41FA5}">
                      <a16:colId xmlns:a16="http://schemas.microsoft.com/office/drawing/2014/main" val="2255167136"/>
                    </a:ext>
                  </a:extLst>
                </a:gridCol>
              </a:tblGrid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kern="100">
                          <a:solidFill>
                            <a:schemeClr val="tx1"/>
                          </a:solidFill>
                          <a:effectLst/>
                        </a:rPr>
                        <a:t>Organism</a:t>
                      </a:r>
                      <a:endParaRPr lang="da-DK" sz="1000" b="1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1" kern="100" dirty="0">
                          <a:solidFill>
                            <a:schemeClr val="tx1"/>
                          </a:solidFill>
                          <a:effectLst/>
                        </a:rPr>
                        <a:t>Taxon ID (</a:t>
                      </a:r>
                      <a:r>
                        <a:rPr lang="en-US" sz="1100" b="1" kern="100" dirty="0" err="1">
                          <a:solidFill>
                            <a:schemeClr val="tx1"/>
                          </a:solidFill>
                          <a:effectLst/>
                        </a:rPr>
                        <a:t>UniProt</a:t>
                      </a:r>
                      <a:r>
                        <a:rPr lang="en-US" sz="1100" b="1" kern="100" dirty="0">
                          <a:solidFill>
                            <a:schemeClr val="tx1"/>
                          </a:solidFill>
                          <a:effectLst/>
                        </a:rPr>
                        <a:t>)</a:t>
                      </a:r>
                      <a:endParaRPr lang="da-DK" sz="1000" b="1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9664350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Alloprevotell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1283313</a:t>
                      </a:r>
                      <a:endParaRPr lang="da-DK" sz="1000" b="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5375157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Prevotell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838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9431503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Lactobacillu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578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5630556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Ruminiclostridium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508657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0038312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Bacteroide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816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34159029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Alistipe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239759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0311001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Parabacteroide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375288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0653506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Bifidobacterium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678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3019203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Blauti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572511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4773092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Roseburi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841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8978299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Paraprevotell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577309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58514241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Streptococcu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301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7756853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Anaerotruncu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244127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3384656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Desulfovibrio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872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8892945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Ruminococcu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263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7120620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Candidatus Saccharimonas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331051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0679153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Lachnoanaerobaculum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164882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40813753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Mucispirillum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248038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42714926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Lachnospir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28050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79673734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Barnesiell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397864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9137686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Tyzzerell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506577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9617041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Turicibacter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91303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36124071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Marvinbryanti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248744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6945570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Oscillospira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>
                          <a:solidFill>
                            <a:schemeClr val="tx1"/>
                          </a:solidFill>
                          <a:effectLst/>
                        </a:rPr>
                        <a:t>119852</a:t>
                      </a:r>
                      <a:endParaRPr lang="da-DK" sz="1000" b="0" kern="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6287355"/>
                  </a:ext>
                </a:extLst>
              </a:tr>
              <a:tr h="195839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Rattus norvegicus</a:t>
                      </a:r>
                      <a:endParaRPr lang="da-DK" sz="1000" b="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1100" b="0" kern="100" dirty="0">
                          <a:solidFill>
                            <a:schemeClr val="tx1"/>
                          </a:solidFill>
                          <a:effectLst/>
                        </a:rPr>
                        <a:t>10116</a:t>
                      </a:r>
                      <a:endParaRPr lang="da-DK" sz="1000" b="0" kern="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1667" marR="61667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9626489"/>
                  </a:ext>
                </a:extLst>
              </a:tr>
            </a:tbl>
          </a:graphicData>
        </a:graphic>
      </p:graphicFrame>
      <p:sp>
        <p:nvSpPr>
          <p:cNvPr id="7" name="Rectangle 1">
            <a:extLst>
              <a:ext uri="{FF2B5EF4-FFF2-40B4-BE49-F238E27FC236}">
                <a16:creationId xmlns:a16="http://schemas.microsoft.com/office/drawing/2014/main" id="{8F9F9978-834F-4085-F71E-65519A2E3EA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22663" y="178435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609578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4</Words>
  <Application>Microsoft Office PowerPoint</Application>
  <PresentationFormat>Widescreen</PresentationFormat>
  <Paragraphs>73</Paragraphs>
  <Slides>8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Aptos</vt:lpstr>
      <vt:lpstr>Aptos Display</vt:lpstr>
      <vt:lpstr>Arial</vt:lpstr>
      <vt:lpstr>Calibri</vt:lpstr>
      <vt:lpstr>Times New Roman</vt:lpstr>
      <vt:lpstr>Office Theme</vt:lpstr>
      <vt:lpstr>Prism 10</vt:lpstr>
      <vt:lpstr>Supporting inform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</dc:title>
  <dc:creator>Daniel Erik Otzen</dc:creator>
  <cp:lastModifiedBy>Daniel Erik Otzen</cp:lastModifiedBy>
  <cp:revision>1</cp:revision>
  <dcterms:created xsi:type="dcterms:W3CDTF">2023-12-15T08:17:34Z</dcterms:created>
  <dcterms:modified xsi:type="dcterms:W3CDTF">2023-12-15T08:18:06Z</dcterms:modified>
</cp:coreProperties>
</file>